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5" r:id="rId2"/>
    <p:sldId id="276" r:id="rId3"/>
    <p:sldId id="284" r:id="rId4"/>
  </p:sldIdLst>
  <p:sldSz cx="6858000" cy="9144000" type="letter"/>
  <p:notesSz cx="7099300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Maryse" initials="M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007DDA"/>
    <a:srgbClr val="FF9953"/>
    <a:srgbClr val="04481B"/>
    <a:srgbClr val="056726"/>
    <a:srgbClr val="079D39"/>
    <a:srgbClr val="00FF00"/>
    <a:srgbClr val="FF6600"/>
    <a:srgbClr val="CC3300"/>
    <a:srgbClr val="F9D6B9"/>
    <a:srgbClr val="F38E07"/>
  </p:clrMru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-1614" y="-7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2" name="Table 5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2963991469"/>
              </p:ext>
            </p:extLst>
          </p:nvPr>
        </p:nvGraphicFramePr>
        <p:xfrm>
          <a:off x="838200" y="533400"/>
          <a:ext cx="4953000" cy="7813359"/>
        </p:xfrm>
        <a:graphic>
          <a:graphicData uri="http://schemas.openxmlformats.org/drawingml/2006/table">
            <a:tbl>
              <a:tblPr/>
              <a:tblGrid>
                <a:gridCol w="893763"/>
                <a:gridCol w="806450"/>
                <a:gridCol w="601662"/>
                <a:gridCol w="669925"/>
                <a:gridCol w="654050"/>
                <a:gridCol w="700088"/>
                <a:gridCol w="627062"/>
              </a:tblGrid>
              <a:tr h="155575">
                <a:tc gridSpan="3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Hydrogen bonds</a:t>
                      </a:r>
                      <a:endParaRPr kumimoji="0" lang="en-CA" sz="8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Buried Surface Area (BSA) of interfacing residues</a:t>
                      </a:r>
                      <a:endParaRPr kumimoji="0" lang="en-CA" sz="800" b="1" i="0" u="none" strike="noStrike" cap="none" normalizeH="0" baseline="3000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</a:tr>
              <a:tr h="179388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f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MA1</a:t>
                      </a: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R1</a:t>
                      </a: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-major</a:t>
                      </a:r>
                      <a:endParaRPr kumimoji="0" lang="en-CA" sz="8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Distance (Å)</a:t>
                      </a:r>
                      <a:endParaRPr kumimoji="0" lang="en-CA" sz="8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f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MA1</a:t>
                      </a:r>
                      <a:endParaRPr kumimoji="0" lang="en-CA" sz="8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BSA (Å</a:t>
                      </a:r>
                      <a:r>
                        <a:rPr kumimoji="0" lang="en-US" sz="8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) &gt;10</a:t>
                      </a:r>
                      <a:endParaRPr kumimoji="0" lang="en-CA" sz="8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R1</a:t>
                      </a: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-major</a:t>
                      </a:r>
                      <a:endParaRPr kumimoji="0" lang="en-CA" sz="8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BSA (Å</a:t>
                      </a:r>
                      <a:r>
                        <a:rPr kumimoji="0" lang="en-US" sz="8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)</a:t>
                      </a:r>
                      <a:endParaRPr kumimoji="0" lang="en-CA" sz="8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Gln141 [Oɛ1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Val-P1 [N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3.6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sp134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3.7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Val-P1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54.3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Gln141 [N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Val-P1 [O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.9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Val137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0.4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he-P2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10.4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Gln141 [O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la-P3 [N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3.0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Thr140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33.8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la-P3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50.4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7DDA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Tyr175</a:t>
                      </a: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 [OH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Leu-P6 [O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.6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Gln141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73.4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Glu-P4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6.6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Tyr251 [OH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ro-P7 [O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.6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Tyr142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87.1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he-P5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25.2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Tyr251 [OH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he-P9 [N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.8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rg143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8.7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Leu-P6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38.2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sp227 [O</a:t>
                      </a:r>
                      <a:r>
                        <a:rPr kumimoji="0" lang="el-GR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δ</a:t>
                      </a:r>
                      <a:r>
                        <a:rPr kumimoji="0" lang="en-CA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Lys-P11 [N</a:t>
                      </a:r>
                      <a:r>
                        <a:rPr kumimoji="0" lang="el-GR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ζ</a:t>
                      </a:r>
                      <a:r>
                        <a:rPr kumimoji="0" lang="en-CA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.9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Thr171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1.9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ro-P7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2.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sp227 [O] 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Lys-P11 [</a:t>
                      </a: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N</a:t>
                      </a:r>
                      <a:r>
                        <a:rPr kumimoji="0" lang="el-GR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ζ</a:t>
                      </a:r>
                      <a:r>
                        <a:rPr kumimoji="0" 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3.26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ＭＳ Ｐゴシック" pitchFamily="6" charset="-128"/>
                        </a:rPr>
                        <a:t> </a:t>
                      </a:r>
                      <a:endParaRPr kumimoji="0" 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Tyr175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53.3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Leu-P8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22.8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sp227 [N]</a:t>
                      </a:r>
                      <a:endParaRPr kumimoji="0" 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ＭＳ Ｐゴシック" pitchFamily="6" charset="-128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Lys-P11 [O] 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3.07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Leu176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9.2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he-P9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70.3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sn228 [N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Lys-P11 [O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3.6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he183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9.6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Ser-P10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.6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7DDA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Ile</a:t>
                      </a: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7DDA"/>
                          </a:solidFill>
                          <a:effectLst/>
                          <a:latin typeface="Symbol" pitchFamily="18" charset="2"/>
                          <a:ea typeface="ＭＳ Ｐゴシック" pitchFamily="6" charset="-128"/>
                        </a:rPr>
                        <a:t>225</a:t>
                      </a: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Symbol" pitchFamily="18" charset="2"/>
                          <a:ea typeface="ＭＳ Ｐゴシック" pitchFamily="6" charset="-128"/>
                        </a:rPr>
                        <a:t> [O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Gly-P13 [N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.9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ro184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5.5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Lys-P11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56.8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7DDA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Ile</a:t>
                      </a: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7DDA"/>
                          </a:solidFill>
                          <a:effectLst/>
                          <a:latin typeface="Symbol" pitchFamily="18" charset="2"/>
                          <a:ea typeface="ＭＳ Ｐゴシック" pitchFamily="6" charset="-128"/>
                        </a:rPr>
                        <a:t>225 </a:t>
                      </a: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Symbol" pitchFamily="18" charset="2"/>
                          <a:ea typeface="ＭＳ Ｐゴシック" pitchFamily="6" charset="-128"/>
                        </a:rPr>
                        <a:t>[N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Gly-P13 [O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.9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Thr186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4.8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he-P12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96.1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sn</a:t>
                      </a: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Symbol" pitchFamily="18" charset="2"/>
                          <a:ea typeface="ＭＳ Ｐゴシック" pitchFamily="6" charset="-128"/>
                        </a:rPr>
                        <a:t>228 [Od1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Gly-P13 [N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3.6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he201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34.8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Gly-P13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60.8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sn223  [O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rg-P15 [N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.8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Tyr202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7.0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Ser-P14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5.7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Gly222 [O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rg-P15 [NH1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.8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sn205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5.3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rg-P15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76.5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7DDA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Met224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 [O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rg-P15 [NH1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3.0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sn223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61.3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Met-P16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11.1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Tyr234 [O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rg-P15 [NH1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3.2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Met224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6.9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His-P17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5.1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Ser232 [O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rg-P15 [NH2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.8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Ile225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69.2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Ile-P18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0.0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Tyr234 [O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rg-P15 [NH2]</a:t>
                      </a:r>
                      <a:endParaRPr kumimoji="0" 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.8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ro226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4.0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sn223 [O</a:t>
                      </a:r>
                      <a:r>
                        <a:rPr kumimoji="0" lang="el-GR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δ</a:t>
                      </a: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Met-P16 [N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3.1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sp227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91.3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fr-FR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ＭＳ Ｐゴシック" pitchFamily="6" charset="-128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fr-FR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ＭＳ Ｐゴシック" pitchFamily="6" charset="-128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fr-FR" sz="1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ＭＳ Ｐゴシック" pitchFamily="6" charset="-128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sn228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46.9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Tyr234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0.2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Lys235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8.9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Tyr251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73.0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la254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4.1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sn257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3.1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Met273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30.4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179388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f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MA1</a:t>
                      </a: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R1</a:t>
                      </a: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-minor</a:t>
                      </a:r>
                      <a:endParaRPr kumimoji="0" lang="en-CA" sz="8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Distance (Å)</a:t>
                      </a:r>
                      <a:endParaRPr kumimoji="0" lang="en-CA" sz="8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f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MA1</a:t>
                      </a:r>
                      <a:endParaRPr kumimoji="0" lang="en-CA" sz="8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BSA (Å</a:t>
                      </a:r>
                      <a:r>
                        <a:rPr kumimoji="0" lang="en-US" sz="8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) &gt;10</a:t>
                      </a:r>
                      <a:endParaRPr kumimoji="0" lang="en-CA" sz="8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R1</a:t>
                      </a: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-minor</a:t>
                      </a:r>
                      <a:endParaRPr kumimoji="0" lang="en-CA" sz="8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BSA (Å</a:t>
                      </a:r>
                      <a:r>
                        <a:rPr kumimoji="0" lang="en-US" sz="8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)</a:t>
                      </a:r>
                      <a:endParaRPr kumimoji="0" lang="en-CA" sz="8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Thr171 [Oɣ1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Glu-P4 [Oɛ1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.9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Thr171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45.6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Glu-P4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53.4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ro185 [O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Leu-P6 [N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3.7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ro184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2.0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he-P5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71.7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7DDA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Glu187</a:t>
                      </a: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 [N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Leu-P6 [O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.9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ro185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55.6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Leu-P6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75.5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Glu187 [O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Leu-P8 [N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3.5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Thr186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40.3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ro-P7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7.1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7DDA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Lys230</a:t>
                      </a:r>
                      <a:r>
                        <a:rPr kumimoji="0" lang="en-CA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 [N</a:t>
                      </a:r>
                      <a:r>
                        <a:rPr kumimoji="0" lang="el-GR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ζ</a:t>
                      </a:r>
                      <a:r>
                        <a:rPr kumimoji="0" lang="en-CA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Ser-P10 [O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3.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Glu187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74.9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Leu-P8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03.3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ro188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3.1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he-P9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39.8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Met190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6.3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Ser-P10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34.0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Met224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3.7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Asn228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52.4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Lys230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5.7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79388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R1</a:t>
                      </a: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-major</a:t>
                      </a:r>
                      <a:endParaRPr kumimoji="0" lang="en-CA" sz="8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R1</a:t>
                      </a: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-minor</a:t>
                      </a:r>
                      <a:endParaRPr kumimoji="0" lang="en-CA" sz="8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Distance (Å)</a:t>
                      </a:r>
                      <a:endParaRPr kumimoji="0" lang="en-CA" sz="8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R1_major</a:t>
                      </a:r>
                      <a:endParaRPr kumimoji="0" lang="en-CA" sz="8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BSA (Å</a:t>
                      </a:r>
                      <a:r>
                        <a:rPr kumimoji="0" lang="en-US" sz="8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) &gt;0</a:t>
                      </a:r>
                      <a:endParaRPr kumimoji="0" lang="en-CA" sz="8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R1</a:t>
                      </a: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-minor</a:t>
                      </a:r>
                      <a:endParaRPr kumimoji="0" lang="en-CA" sz="8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BSA (Å</a:t>
                      </a:r>
                      <a:r>
                        <a:rPr kumimoji="0" lang="en-US" sz="800" b="0" i="0" u="none" strike="noStrike" cap="none" normalizeH="0" baseline="3000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)</a:t>
                      </a:r>
                      <a:endParaRPr kumimoji="0" lang="en-CA" sz="800" b="1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he-P12 [O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he-P9 [N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.8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Leu-P8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5.7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Glu-P4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39.2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he-P12 [N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ro-P7 [O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3.3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he-P9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7.7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he-P5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.1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Ser-P14 [N]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he-P9 [O]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3.4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Ser-P10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43.0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Leu-P6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57.1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Lys-P11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44.6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ro-P7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31.1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he-P12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69.5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Leu-P8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54.3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Gly-P13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18.8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Phe-P9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71.7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Ser-P14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24.7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Ser-P10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38.4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His-P17</a:t>
                      </a: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CA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ＭＳ Ｐゴシック" pitchFamily="6" charset="-128"/>
                          <a:cs typeface="Times New Roman" pitchFamily="18" charset="0"/>
                        </a:rPr>
                        <a:t>35.6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CA" sz="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ＭＳ Ｐゴシック" pitchFamily="6" charset="-128"/>
                        <a:cs typeface="Times New Roman" pitchFamily="18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4" name="ZoneTexte 3"/>
          <p:cNvSpPr txBox="1"/>
          <p:nvPr/>
        </p:nvSpPr>
        <p:spPr>
          <a:xfrm>
            <a:off x="590551" y="49530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A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ZoneTexte 4"/>
          <p:cNvSpPr txBox="1"/>
          <p:nvPr/>
        </p:nvSpPr>
        <p:spPr>
          <a:xfrm>
            <a:off x="590551" y="510242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B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ZoneTexte 5"/>
          <p:cNvSpPr txBox="1"/>
          <p:nvPr/>
        </p:nvSpPr>
        <p:spPr>
          <a:xfrm>
            <a:off x="590551" y="685800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C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/>
          <p:cNvGraphicFramePr>
            <a:graphicFrameLocks noGrp="1"/>
          </p:cNvGraphicFramePr>
          <p:nvPr/>
        </p:nvGraphicFramePr>
        <p:xfrm>
          <a:off x="1219200" y="838200"/>
          <a:ext cx="4724401" cy="1295400"/>
        </p:xfrm>
        <a:graphic>
          <a:graphicData uri="http://schemas.openxmlformats.org/drawingml/2006/table">
            <a:tbl>
              <a:tblPr/>
              <a:tblGrid>
                <a:gridCol w="928692"/>
                <a:gridCol w="517293"/>
                <a:gridCol w="517900"/>
                <a:gridCol w="603711"/>
                <a:gridCol w="776547"/>
                <a:gridCol w="776547"/>
                <a:gridCol w="603711"/>
              </a:tblGrid>
              <a:tr h="381248">
                <a:tc>
                  <a:txBody>
                    <a:bodyPr/>
                    <a:lstStyle/>
                    <a:p>
                      <a:pPr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Residue no.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3D7</a:t>
                      </a:r>
                      <a:r>
                        <a:rPr lang="en-CA" sz="1100" b="0" cap="none" baseline="30000" dirty="0">
                          <a:latin typeface="Times New Roman"/>
                          <a:ea typeface="Cambria"/>
                          <a:cs typeface="Times New Roman"/>
                        </a:rPr>
                        <a:t>+</a:t>
                      </a: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*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D10</a:t>
                      </a:r>
                      <a:r>
                        <a:rPr lang="en-CA" sz="1100" b="0" cap="none" baseline="30000" dirty="0">
                          <a:latin typeface="Times New Roman"/>
                          <a:ea typeface="Cambria"/>
                          <a:cs typeface="Times New Roman"/>
                        </a:rPr>
                        <a:t>+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HB3</a:t>
                      </a:r>
                      <a:r>
                        <a:rPr lang="en-CA" sz="1100" b="0" cap="none" baseline="30000" dirty="0">
                          <a:latin typeface="Times New Roman"/>
                          <a:ea typeface="Cambria"/>
                          <a:cs typeface="Times New Roman"/>
                        </a:rPr>
                        <a:t>+</a:t>
                      </a: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*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W2mef</a:t>
                      </a:r>
                      <a:r>
                        <a:rPr lang="en-CA" sz="1100" b="0" cap="none" baseline="30000" dirty="0">
                          <a:latin typeface="Times New Roman"/>
                          <a:ea typeface="Cambria"/>
                          <a:cs typeface="Times New Roman"/>
                        </a:rPr>
                        <a:t>+</a:t>
                      </a: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*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3D7mut°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Dico3°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04469">
                <a:tc>
                  <a:txBody>
                    <a:bodyPr/>
                    <a:lstStyle/>
                    <a:p>
                      <a:pPr>
                        <a:spcBef>
                          <a:spcPts val="1000"/>
                        </a:spcBef>
                        <a:spcAft>
                          <a:spcPts val="1000"/>
                        </a:spcAft>
                      </a:pPr>
                      <a:r>
                        <a:rPr lang="en-CA" sz="1100" b="0" cap="all" dirty="0">
                          <a:latin typeface="Times New Roman"/>
                          <a:ea typeface="Cambria"/>
                          <a:cs typeface="Times New Roman"/>
                        </a:rPr>
                        <a:t>175</a:t>
                      </a:r>
                      <a:endParaRPr lang="fr-FR" sz="1100" b="1" cap="all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Tyr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>
                          <a:latin typeface="Times New Roman"/>
                          <a:ea typeface="Cambria"/>
                          <a:cs typeface="Times New Roman"/>
                        </a:rPr>
                        <a:t>Tyr</a:t>
                      </a:r>
                      <a:endParaRPr lang="fr-FR" sz="1100" b="1" cap="none" baseline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>
                          <a:latin typeface="Times New Roman"/>
                          <a:ea typeface="Cambria"/>
                          <a:cs typeface="Times New Roman"/>
                        </a:rPr>
                        <a:t>Asp</a:t>
                      </a:r>
                      <a:endParaRPr lang="fr-FR" sz="1100" b="1" cap="none" baseline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>
                          <a:latin typeface="Times New Roman"/>
                          <a:ea typeface="Cambria"/>
                          <a:cs typeface="Times New Roman"/>
                        </a:rPr>
                        <a:t>Tyr</a:t>
                      </a:r>
                      <a:endParaRPr lang="fr-FR" sz="1100" b="1" cap="none" baseline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>
                          <a:latin typeface="Times New Roman"/>
                          <a:ea typeface="Cambria"/>
                          <a:cs typeface="Times New Roman"/>
                        </a:rPr>
                        <a:t>Tyr</a:t>
                      </a:r>
                      <a:endParaRPr lang="fr-FR" sz="1100" b="1" cap="none" baseline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Asp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42859">
                <a:tc>
                  <a:txBody>
                    <a:bodyPr/>
                    <a:lstStyle/>
                    <a:p>
                      <a:pPr>
                        <a:spcBef>
                          <a:spcPts val="1000"/>
                        </a:spcBef>
                        <a:spcAft>
                          <a:spcPts val="1000"/>
                        </a:spcAft>
                      </a:pPr>
                      <a:r>
                        <a:rPr lang="en-CA" sz="1100" b="0" cap="all">
                          <a:latin typeface="Times New Roman"/>
                          <a:ea typeface="Cambria"/>
                          <a:cs typeface="Times New Roman"/>
                        </a:rPr>
                        <a:t>224</a:t>
                      </a:r>
                      <a:endParaRPr lang="fr-FR" sz="1100" b="1" cap="all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Met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Met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Met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Met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89560" algn="l"/>
                          <a:tab pos="336550" algn="ctr"/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	</a:t>
                      </a:r>
                      <a:r>
                        <a:rPr lang="en-CA" sz="1100" b="0" cap="none" baseline="0" dirty="0" smtClean="0">
                          <a:latin typeface="Times New Roman"/>
                          <a:ea typeface="Cambria"/>
                          <a:cs typeface="Times New Roman"/>
                        </a:rPr>
                        <a:t>Met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>
                          <a:latin typeface="Times New Roman"/>
                          <a:ea typeface="Cambria"/>
                          <a:cs typeface="Times New Roman"/>
                        </a:rPr>
                        <a:t>Met</a:t>
                      </a:r>
                      <a:endParaRPr lang="fr-FR" sz="1100" b="1" cap="none" baseline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6824">
                <a:tc>
                  <a:txBody>
                    <a:bodyPr/>
                    <a:lstStyle/>
                    <a:p>
                      <a:pPr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all" dirty="0">
                          <a:latin typeface="Times New Roman"/>
                          <a:ea typeface="Cambria"/>
                          <a:cs typeface="Times New Roman"/>
                        </a:rPr>
                        <a:t>225</a:t>
                      </a:r>
                      <a:endParaRPr lang="fr-FR" sz="1100" b="1" cap="all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Ile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>
                          <a:latin typeface="Times New Roman"/>
                          <a:ea typeface="Cambria"/>
                          <a:cs typeface="Times New Roman"/>
                        </a:rPr>
                        <a:t>Ile</a:t>
                      </a:r>
                      <a:endParaRPr lang="fr-FR" sz="1100" b="1" cap="none" baseline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 err="1">
                          <a:latin typeface="Times New Roman"/>
                          <a:ea typeface="Cambria"/>
                          <a:cs typeface="Times New Roman"/>
                        </a:rPr>
                        <a:t>Asn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 err="1">
                          <a:latin typeface="Times New Roman"/>
                          <a:ea typeface="Cambria"/>
                          <a:cs typeface="Times New Roman"/>
                        </a:rPr>
                        <a:t>Asn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 err="1">
                          <a:latin typeface="Times New Roman"/>
                          <a:ea typeface="Cambria"/>
                          <a:cs typeface="Times New Roman"/>
                        </a:rPr>
                        <a:t>Asn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Ile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6" name="ZoneTexte 5"/>
          <p:cNvSpPr txBox="1"/>
          <p:nvPr/>
        </p:nvSpPr>
        <p:spPr>
          <a:xfrm>
            <a:off x="1143000" y="228600"/>
            <a:ext cx="5638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Table S2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ZoneTexte 6"/>
          <p:cNvSpPr txBox="1"/>
          <p:nvPr/>
        </p:nvSpPr>
        <p:spPr>
          <a:xfrm>
            <a:off x="1143000" y="609600"/>
            <a:ext cx="5638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A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2" name="Tableau 11"/>
          <p:cNvGraphicFramePr>
            <a:graphicFrameLocks noGrp="1"/>
          </p:cNvGraphicFramePr>
          <p:nvPr/>
        </p:nvGraphicFramePr>
        <p:xfrm>
          <a:off x="1219200" y="2674944"/>
          <a:ext cx="4724401" cy="914400"/>
        </p:xfrm>
        <a:graphic>
          <a:graphicData uri="http://schemas.openxmlformats.org/drawingml/2006/table">
            <a:tbl>
              <a:tblPr/>
              <a:tblGrid>
                <a:gridCol w="928692"/>
                <a:gridCol w="517293"/>
                <a:gridCol w="517900"/>
                <a:gridCol w="603711"/>
                <a:gridCol w="776547"/>
                <a:gridCol w="776547"/>
                <a:gridCol w="603711"/>
              </a:tblGrid>
              <a:tr h="338928">
                <a:tc>
                  <a:txBody>
                    <a:bodyPr/>
                    <a:lstStyle/>
                    <a:p>
                      <a:pPr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Residue no.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3D7*</a:t>
                      </a:r>
                      <a:r>
                        <a:rPr lang="en-CA" sz="1100" b="0" cap="none" baseline="30000" dirty="0">
                          <a:latin typeface="Times New Roman"/>
                          <a:ea typeface="Cambria"/>
                          <a:cs typeface="Times New Roman"/>
                        </a:rPr>
                        <a:t>+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D10</a:t>
                      </a:r>
                      <a:r>
                        <a:rPr lang="en-CA" sz="1100" b="0" cap="none" baseline="30000" dirty="0">
                          <a:latin typeface="Times New Roman"/>
                          <a:ea typeface="Cambria"/>
                          <a:cs typeface="Times New Roman"/>
                        </a:rPr>
                        <a:t>+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HB3</a:t>
                      </a:r>
                      <a:r>
                        <a:rPr lang="en-CA" sz="1100" b="0" cap="none" baseline="30000" dirty="0">
                          <a:latin typeface="Times New Roman"/>
                          <a:ea typeface="Cambria"/>
                          <a:cs typeface="Times New Roman"/>
                        </a:rPr>
                        <a:t>+</a:t>
                      </a: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*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W2mef</a:t>
                      </a:r>
                      <a:r>
                        <a:rPr lang="en-CA" sz="1100" b="0" cap="none" baseline="30000" dirty="0">
                          <a:latin typeface="Times New Roman"/>
                          <a:ea typeface="Cambria"/>
                          <a:cs typeface="Times New Roman"/>
                        </a:rPr>
                        <a:t>+</a:t>
                      </a: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*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3D7mut°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Dico3°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0672">
                <a:tc>
                  <a:txBody>
                    <a:bodyPr/>
                    <a:lstStyle/>
                    <a:p>
                      <a:pPr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all" dirty="0">
                          <a:latin typeface="Times New Roman"/>
                          <a:ea typeface="Cambria"/>
                          <a:cs typeface="Times New Roman"/>
                        </a:rPr>
                        <a:t>187</a:t>
                      </a:r>
                      <a:endParaRPr lang="fr-FR" sz="1100" b="1" cap="all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 err="1">
                          <a:latin typeface="Times New Roman"/>
                          <a:ea typeface="Cambria"/>
                          <a:cs typeface="Times New Roman"/>
                        </a:rPr>
                        <a:t>Glu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 err="1">
                          <a:latin typeface="Times New Roman"/>
                          <a:ea typeface="Cambria"/>
                          <a:cs typeface="Times New Roman"/>
                        </a:rPr>
                        <a:t>Glu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 err="1">
                          <a:latin typeface="Times New Roman"/>
                          <a:ea typeface="Cambria"/>
                          <a:cs typeface="Times New Roman"/>
                        </a:rPr>
                        <a:t>Glu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Lys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 err="1">
                          <a:latin typeface="Times New Roman"/>
                          <a:ea typeface="Cambria"/>
                          <a:cs typeface="Times New Roman"/>
                        </a:rPr>
                        <a:t>Glu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 err="1">
                          <a:latin typeface="Times New Roman"/>
                          <a:ea typeface="Cambria"/>
                          <a:cs typeface="Times New Roman"/>
                        </a:rPr>
                        <a:t>Glu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04800">
                <a:tc>
                  <a:txBody>
                    <a:bodyPr/>
                    <a:lstStyle/>
                    <a:p>
                      <a:pPr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all" dirty="0">
                          <a:latin typeface="Times New Roman"/>
                          <a:ea typeface="Cambria"/>
                          <a:cs typeface="Times New Roman"/>
                        </a:rPr>
                        <a:t>230</a:t>
                      </a:r>
                      <a:endParaRPr lang="fr-FR" sz="1100" b="1" cap="all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Lys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Lys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Lys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Lys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Lys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Lys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aphicFrame>
        <p:nvGraphicFramePr>
          <p:cNvPr id="13" name="Tableau 12"/>
          <p:cNvGraphicFramePr>
            <a:graphicFrameLocks noGrp="1"/>
          </p:cNvGraphicFramePr>
          <p:nvPr/>
        </p:nvGraphicFramePr>
        <p:xfrm>
          <a:off x="1219200" y="4038600"/>
          <a:ext cx="4724401" cy="914400"/>
        </p:xfrm>
        <a:graphic>
          <a:graphicData uri="http://schemas.openxmlformats.org/drawingml/2006/table">
            <a:tbl>
              <a:tblPr/>
              <a:tblGrid>
                <a:gridCol w="928692"/>
                <a:gridCol w="517292"/>
                <a:gridCol w="517901"/>
                <a:gridCol w="603711"/>
                <a:gridCol w="776547"/>
                <a:gridCol w="776547"/>
                <a:gridCol w="603711"/>
              </a:tblGrid>
              <a:tr h="338928">
                <a:tc>
                  <a:txBody>
                    <a:bodyPr/>
                    <a:lstStyle/>
                    <a:p>
                      <a:pPr>
                        <a:spcAft>
                          <a:spcPts val="1000"/>
                        </a:spcAft>
                      </a:pPr>
                      <a:endParaRPr lang="en-CA" sz="1100" b="0" cap="all" dirty="0">
                        <a:latin typeface="Times New Roman"/>
                        <a:ea typeface="Cambria"/>
                        <a:cs typeface="Times New Roman"/>
                      </a:endParaRPr>
                    </a:p>
                  </a:txBody>
                  <a:tcPr marL="63549" marR="63549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3D7</a:t>
                      </a:r>
                      <a:r>
                        <a:rPr lang="en-CA" sz="1100" b="0" cap="none" baseline="30000" dirty="0">
                          <a:latin typeface="Times New Roman"/>
                          <a:ea typeface="Cambria"/>
                          <a:cs typeface="Times New Roman"/>
                        </a:rPr>
                        <a:t>+</a:t>
                      </a: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*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D10</a:t>
                      </a:r>
                      <a:r>
                        <a:rPr lang="en-CA" sz="1100" b="0" cap="none" baseline="30000" dirty="0">
                          <a:latin typeface="Times New Roman"/>
                          <a:ea typeface="Cambria"/>
                          <a:cs typeface="Times New Roman"/>
                        </a:rPr>
                        <a:t>+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HB3</a:t>
                      </a:r>
                      <a:r>
                        <a:rPr lang="en-CA" sz="1100" b="0" cap="none" baseline="30000" dirty="0">
                          <a:latin typeface="Times New Roman"/>
                          <a:ea typeface="Cambria"/>
                          <a:cs typeface="Times New Roman"/>
                        </a:rPr>
                        <a:t>+</a:t>
                      </a: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*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W2mef</a:t>
                      </a:r>
                      <a:r>
                        <a:rPr lang="en-CA" sz="1100" b="0" cap="none" baseline="30000" dirty="0">
                          <a:latin typeface="Times New Roman"/>
                          <a:ea typeface="Cambria"/>
                          <a:cs typeface="Times New Roman"/>
                        </a:rPr>
                        <a:t>+</a:t>
                      </a: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*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3D7mut°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</a:pPr>
                      <a:r>
                        <a:rPr lang="en-CA" sz="1100" b="0" cap="none" dirty="0">
                          <a:latin typeface="Times New Roman"/>
                          <a:ea typeface="Cambria"/>
                          <a:cs typeface="Times New Roman"/>
                        </a:rPr>
                        <a:t>Dico3°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2728">
                <a:tc>
                  <a:txBody>
                    <a:bodyPr/>
                    <a:lstStyle/>
                    <a:p>
                      <a:pPr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all" dirty="0">
                          <a:latin typeface="Times New Roman"/>
                          <a:ea typeface="Cambria"/>
                          <a:cs typeface="Times New Roman"/>
                        </a:rPr>
                        <a:t>K</a:t>
                      </a:r>
                      <a:r>
                        <a:rPr lang="en-CA" sz="1100" b="0" cap="all" baseline="-25000" dirty="0">
                          <a:latin typeface="Times New Roman"/>
                          <a:ea typeface="Cambria"/>
                          <a:cs typeface="Times New Roman"/>
                        </a:rPr>
                        <a:t>D</a:t>
                      </a:r>
                      <a:r>
                        <a:rPr lang="en-CA" sz="1100" b="0" cap="all" dirty="0">
                          <a:latin typeface="Times New Roman"/>
                          <a:ea typeface="Cambria"/>
                          <a:cs typeface="Times New Roman"/>
                        </a:rPr>
                        <a:t> (µM)</a:t>
                      </a:r>
                      <a:endParaRPr lang="fr-FR" sz="1100" b="1" cap="all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all">
                          <a:latin typeface="Times New Roman"/>
                          <a:ea typeface="Cambria"/>
                          <a:cs typeface="Times New Roman"/>
                        </a:rPr>
                        <a:t>0.080</a:t>
                      </a:r>
                      <a:endParaRPr lang="fr-FR" sz="1100" b="1" cap="all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all" dirty="0">
                          <a:latin typeface="Times New Roman"/>
                          <a:ea typeface="Cambria"/>
                          <a:cs typeface="Times New Roman"/>
                        </a:rPr>
                        <a:t>-</a:t>
                      </a:r>
                      <a:endParaRPr lang="fr-FR" sz="1100" b="1" cap="all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all" dirty="0">
                          <a:latin typeface="Times New Roman"/>
                          <a:ea typeface="Cambria"/>
                          <a:cs typeface="Times New Roman"/>
                        </a:rPr>
                        <a:t>68</a:t>
                      </a:r>
                      <a:endParaRPr lang="fr-FR" sz="1100" b="1" cap="all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all">
                          <a:latin typeface="Times New Roman"/>
                          <a:ea typeface="Cambria"/>
                          <a:cs typeface="Times New Roman"/>
                        </a:rPr>
                        <a:t>16</a:t>
                      </a:r>
                      <a:endParaRPr lang="fr-FR" sz="1100" b="1" cap="all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all" dirty="0" smtClean="0">
                          <a:latin typeface="Times New Roman"/>
                          <a:ea typeface="Cambria"/>
                          <a:cs typeface="Times New Roman"/>
                        </a:rPr>
                        <a:t>15</a:t>
                      </a:r>
                      <a:endParaRPr lang="fr-FR" sz="1100" b="1" cap="all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all" smtClean="0">
                          <a:latin typeface="Times New Roman"/>
                          <a:ea typeface="Cambria"/>
                          <a:cs typeface="Times New Roman"/>
                        </a:rPr>
                        <a:t>22</a:t>
                      </a:r>
                      <a:endParaRPr lang="fr-FR" sz="1100" b="1" cap="all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2744">
                <a:tc>
                  <a:txBody>
                    <a:bodyPr/>
                    <a:lstStyle/>
                    <a:p>
                      <a:pPr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none" baseline="0" dirty="0">
                          <a:latin typeface="Times New Roman"/>
                          <a:ea typeface="Cambria"/>
                          <a:cs typeface="Times New Roman"/>
                        </a:rPr>
                        <a:t>Binding</a:t>
                      </a:r>
                      <a:endParaRPr lang="fr-FR" sz="1100" b="1" cap="none" baseline="0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all" dirty="0">
                          <a:latin typeface="Times New Roman"/>
                          <a:ea typeface="Cambria"/>
                          <a:cs typeface="Times New Roman"/>
                        </a:rPr>
                        <a:t>s</a:t>
                      </a:r>
                      <a:endParaRPr lang="fr-FR" sz="1100" b="1" cap="all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all" dirty="0">
                          <a:latin typeface="Times New Roman"/>
                          <a:ea typeface="Cambria"/>
                          <a:cs typeface="Times New Roman"/>
                        </a:rPr>
                        <a:t>s</a:t>
                      </a:r>
                      <a:endParaRPr lang="fr-FR" sz="1100" b="1" cap="all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all" dirty="0">
                          <a:latin typeface="Times New Roman"/>
                          <a:ea typeface="Cambria"/>
                          <a:cs typeface="Times New Roman"/>
                        </a:rPr>
                        <a:t>w</a:t>
                      </a:r>
                      <a:endParaRPr lang="fr-FR" sz="1100" b="1" cap="all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all" dirty="0">
                          <a:latin typeface="Times New Roman"/>
                          <a:ea typeface="Cambria"/>
                          <a:cs typeface="Times New Roman"/>
                        </a:rPr>
                        <a:t>w</a:t>
                      </a:r>
                      <a:endParaRPr lang="fr-FR" sz="1100" b="1" cap="all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all" dirty="0">
                          <a:latin typeface="Times New Roman"/>
                          <a:ea typeface="Cambria"/>
                          <a:cs typeface="Times New Roman"/>
                        </a:rPr>
                        <a:t>w</a:t>
                      </a:r>
                      <a:endParaRPr lang="fr-FR" sz="1100" b="1" cap="all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1000"/>
                        </a:spcBef>
                        <a:spcAft>
                          <a:spcPts val="1000"/>
                        </a:spcAft>
                        <a:tabLst>
                          <a:tab pos="2986405" algn="ctr"/>
                          <a:tab pos="5972810" algn="r"/>
                        </a:tabLst>
                      </a:pPr>
                      <a:r>
                        <a:rPr lang="en-CA" sz="1100" b="0" cap="all" dirty="0">
                          <a:latin typeface="Times New Roman"/>
                          <a:ea typeface="Cambria"/>
                          <a:cs typeface="Times New Roman"/>
                        </a:rPr>
                        <a:t>w</a:t>
                      </a:r>
                      <a:endParaRPr lang="fr-FR" sz="1100" b="1" cap="all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63549" marR="6354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14" name="ZoneTexte 13"/>
          <p:cNvSpPr txBox="1"/>
          <p:nvPr/>
        </p:nvSpPr>
        <p:spPr>
          <a:xfrm>
            <a:off x="1143000" y="2313801"/>
            <a:ext cx="5638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B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ZoneTexte 14"/>
          <p:cNvSpPr txBox="1"/>
          <p:nvPr/>
        </p:nvSpPr>
        <p:spPr>
          <a:xfrm>
            <a:off x="1143000" y="3837801"/>
            <a:ext cx="5638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C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au 1"/>
          <p:cNvGraphicFramePr>
            <a:graphicFrameLocks noGrp="1"/>
          </p:cNvGraphicFramePr>
          <p:nvPr/>
        </p:nvGraphicFramePr>
        <p:xfrm>
          <a:off x="228600" y="2286000"/>
          <a:ext cx="6324601" cy="4724404"/>
        </p:xfrm>
        <a:graphic>
          <a:graphicData uri="http://schemas.openxmlformats.org/drawingml/2006/table">
            <a:tbl>
              <a:tblPr/>
              <a:tblGrid>
                <a:gridCol w="560320"/>
                <a:gridCol w="2792480"/>
                <a:gridCol w="1208210"/>
                <a:gridCol w="1763591"/>
              </a:tblGrid>
              <a:tr h="184288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100" b="1" cap="none" dirty="0">
                          <a:latin typeface="Courier"/>
                          <a:ea typeface="Calibri"/>
                          <a:cs typeface="Times New Roman"/>
                        </a:rPr>
                        <a:t>Name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100" b="1" cap="none" dirty="0">
                          <a:latin typeface="Courier"/>
                          <a:ea typeface="Calibri"/>
                          <a:cs typeface="Times New Roman"/>
                        </a:rPr>
                        <a:t>Sequence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100" b="1" cap="none" dirty="0" smtClean="0">
                          <a:latin typeface="Courier"/>
                          <a:ea typeface="Cambria"/>
                          <a:cs typeface="Times New Roman"/>
                        </a:rPr>
                        <a:t>Used</a:t>
                      </a:r>
                      <a:r>
                        <a:rPr lang="en-US" sz="1100" b="1" cap="none" baseline="0" dirty="0" smtClean="0">
                          <a:latin typeface="Courier"/>
                          <a:ea typeface="Cambria"/>
                          <a:cs typeface="Times New Roman"/>
                        </a:rPr>
                        <a:t> for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fr-FR" sz="1100" b="1" cap="none" dirty="0" err="1" smtClean="0">
                          <a:latin typeface="Courier"/>
                          <a:ea typeface="Cambria"/>
                          <a:cs typeface="Times New Roman"/>
                        </a:rPr>
                        <a:t>Cloned</a:t>
                      </a:r>
                      <a:r>
                        <a:rPr lang="fr-FR" sz="1100" b="1" cap="none" dirty="0" smtClean="0">
                          <a:latin typeface="Courier"/>
                          <a:ea typeface="Cambria"/>
                          <a:cs typeface="Times New Roman"/>
                        </a:rPr>
                        <a:t> in</a:t>
                      </a:r>
                      <a:endParaRPr lang="fr-FR" sz="11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498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ML754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CTAGCTGTTTTACAACTGCAATGTCTCCTCCACAAC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 smtClean="0">
                          <a:latin typeface="Courier"/>
                          <a:ea typeface="Calibri"/>
                          <a:cs typeface="Times New Roman"/>
                        </a:rPr>
                        <a:t>GST-PfRON25</a:t>
                      </a:r>
                      <a:r>
                        <a:rPr lang="en-US" sz="1000" b="0" cap="none" baseline="-25000" dirty="0" smtClean="0">
                          <a:latin typeface="Courier"/>
                          <a:ea typeface="Calibri"/>
                          <a:cs typeface="Times New Roman"/>
                        </a:rPr>
                        <a:t>R2041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fr-FR" sz="1000" b="0" cap="none" dirty="0" err="1" smtClean="0">
                          <a:latin typeface="Courier"/>
                          <a:ea typeface="Cambria"/>
                          <a:cs typeface="Times New Roman"/>
                        </a:rPr>
                        <a:t>pGEX</a:t>
                      </a:r>
                      <a:r>
                        <a:rPr lang="fr-FR" sz="1000" b="0" cap="none" dirty="0" smtClean="0">
                          <a:latin typeface="Courier"/>
                          <a:ea typeface="Cambria"/>
                          <a:cs typeface="Times New Roman"/>
                        </a:rPr>
                        <a:t>-4T3</a:t>
                      </a:r>
                      <a:endParaRPr lang="fr-FR" sz="1000" b="0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498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55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GTTGTGGAGGAGACATTGCAGTTGTAAAACAGCTAG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 smtClean="0">
                          <a:latin typeface="Courier"/>
                          <a:ea typeface="Calibri"/>
                          <a:cs typeface="Times New Roman"/>
                        </a:rPr>
                        <a:t>GST-PfRON2</a:t>
                      </a:r>
                      <a:r>
                        <a:rPr lang="en-US" sz="1000" b="0" cap="none" baseline="-25000" dirty="0" smtClean="0">
                          <a:latin typeface="Courier"/>
                          <a:ea typeface="Calibri"/>
                          <a:cs typeface="Times New Roman"/>
                        </a:rPr>
                        <a:t>R2041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b="0" cap="none" dirty="0" err="1" smtClean="0">
                          <a:latin typeface="Courier"/>
                          <a:ea typeface="Cambria"/>
                          <a:cs typeface="Times New Roman"/>
                        </a:rPr>
                        <a:t>pGEX</a:t>
                      </a:r>
                      <a:r>
                        <a:rPr lang="fr-FR" sz="1000" b="0" cap="none" dirty="0" smtClean="0">
                          <a:latin typeface="Courier"/>
                          <a:ea typeface="Cambria"/>
                          <a:cs typeface="Times New Roman"/>
                        </a:rPr>
                        <a:t>-4T3</a:t>
                      </a: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085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56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CAACTAGAATGTCTGCTCCACAACAAATATG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 smtClean="0">
                          <a:latin typeface="Courier"/>
                          <a:ea typeface="Calibri"/>
                          <a:cs typeface="Times New Roman"/>
                        </a:rPr>
                        <a:t>GST-PfRON2</a:t>
                      </a:r>
                      <a:r>
                        <a:rPr lang="en-US" sz="1000" b="0" cap="none" baseline="-25000" dirty="0" smtClean="0">
                          <a:latin typeface="Courier"/>
                          <a:ea typeface="Calibri"/>
                          <a:cs typeface="Times New Roman"/>
                        </a:rPr>
                        <a:t>P2044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b="0" cap="none" dirty="0" err="1" smtClean="0">
                          <a:latin typeface="Courier"/>
                          <a:ea typeface="Cambria"/>
                          <a:cs typeface="Times New Roman"/>
                        </a:rPr>
                        <a:t>pGEX</a:t>
                      </a:r>
                      <a:r>
                        <a:rPr lang="fr-FR" sz="1000" b="0" cap="none" dirty="0" smtClean="0">
                          <a:latin typeface="Courier"/>
                          <a:ea typeface="Cambria"/>
                          <a:cs typeface="Times New Roman"/>
                        </a:rPr>
                        <a:t>-4T3</a:t>
                      </a: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085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57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CATATTTGTTGTGGAGCAGACATTCTAGTTG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 smtClean="0">
                          <a:latin typeface="Courier"/>
                          <a:ea typeface="Calibri"/>
                          <a:cs typeface="Times New Roman"/>
                        </a:rPr>
                        <a:t>GST-PfRON2</a:t>
                      </a:r>
                      <a:r>
                        <a:rPr lang="en-US" sz="1000" b="0" cap="none" baseline="-25000" dirty="0" smtClean="0">
                          <a:latin typeface="Courier"/>
                          <a:ea typeface="Calibri"/>
                          <a:cs typeface="Times New Roman"/>
                        </a:rPr>
                        <a:t>P2044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b="0" cap="none" dirty="0" err="1" smtClean="0">
                          <a:latin typeface="Courier"/>
                          <a:ea typeface="Cambria"/>
                          <a:cs typeface="Times New Roman"/>
                        </a:rPr>
                        <a:t>pGEX</a:t>
                      </a:r>
                      <a:r>
                        <a:rPr lang="fr-FR" sz="1000" b="0" cap="none" dirty="0" smtClean="0">
                          <a:latin typeface="Courier"/>
                          <a:ea typeface="Cambria"/>
                          <a:cs typeface="Times New Roman"/>
                        </a:rPr>
                        <a:t>-4T3</a:t>
                      </a: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498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58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GATATAGGTGCAGGAGCAGTAGCTAGCTGTTTTAC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 smtClean="0">
                          <a:latin typeface="Courier"/>
                          <a:ea typeface="Calibri"/>
                          <a:cs typeface="Times New Roman"/>
                        </a:rPr>
                        <a:t>GST-PfRON2</a:t>
                      </a:r>
                      <a:r>
                        <a:rPr lang="en-US" sz="1000" b="0" cap="none" baseline="-25000" dirty="0" smtClean="0">
                          <a:latin typeface="Courier"/>
                          <a:ea typeface="Calibri"/>
                          <a:cs typeface="Times New Roman"/>
                        </a:rPr>
                        <a:t>P2033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b="0" cap="none" dirty="0" err="1" smtClean="0">
                          <a:latin typeface="Courier"/>
                          <a:ea typeface="Cambria"/>
                          <a:cs typeface="Times New Roman"/>
                        </a:rPr>
                        <a:t>pGEX</a:t>
                      </a:r>
                      <a:r>
                        <a:rPr lang="fr-FR" sz="1000" b="0" cap="none" dirty="0" smtClean="0">
                          <a:latin typeface="Courier"/>
                          <a:ea typeface="Cambria"/>
                          <a:cs typeface="Times New Roman"/>
                        </a:rPr>
                        <a:t>-4T3</a:t>
                      </a: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498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59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GTAAAACAGCTAGCTACTGCTCCTGCACCTATATC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 smtClean="0">
                          <a:latin typeface="Courier"/>
                          <a:ea typeface="Calibri"/>
                          <a:cs typeface="Times New Roman"/>
                        </a:rPr>
                        <a:t>GST-PfRON2</a:t>
                      </a:r>
                      <a:r>
                        <a:rPr lang="en-US" sz="1000" b="0" cap="none" baseline="-25000" dirty="0" smtClean="0">
                          <a:latin typeface="Courier"/>
                          <a:ea typeface="Calibri"/>
                          <a:cs typeface="Times New Roman"/>
                        </a:rPr>
                        <a:t>P2033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b="0" cap="none" dirty="0" err="1" smtClean="0">
                          <a:latin typeface="Courier"/>
                          <a:ea typeface="Cambria"/>
                          <a:cs typeface="Times New Roman"/>
                        </a:rPr>
                        <a:t>pGEX</a:t>
                      </a:r>
                      <a:r>
                        <a:rPr lang="fr-FR" sz="1000" b="0" cap="none" dirty="0" smtClean="0">
                          <a:latin typeface="Courier"/>
                          <a:ea typeface="Cambria"/>
                          <a:cs typeface="Times New Roman"/>
                        </a:rPr>
                        <a:t>-4T3</a:t>
                      </a: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498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60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GACCAGTAGCTAGCTGTGCTACAACTAGAATGTCTC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 smtClean="0">
                          <a:latin typeface="Courier"/>
                          <a:ea typeface="Calibri"/>
                          <a:cs typeface="Times New Roman"/>
                        </a:rPr>
                        <a:t>GST-PfRON2</a:t>
                      </a:r>
                      <a:r>
                        <a:rPr lang="en-US" sz="1000" b="0" cap="none" baseline="-25000" dirty="0" smtClean="0">
                          <a:latin typeface="Courier"/>
                          <a:ea typeface="Calibri"/>
                          <a:cs typeface="Times New Roman"/>
                        </a:rPr>
                        <a:t>F2038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b="0" cap="none" dirty="0" err="1" smtClean="0">
                          <a:latin typeface="Courier"/>
                          <a:ea typeface="Cambria"/>
                          <a:cs typeface="Times New Roman"/>
                        </a:rPr>
                        <a:t>pGEX</a:t>
                      </a:r>
                      <a:r>
                        <a:rPr lang="fr-FR" sz="1000" b="0" cap="none" dirty="0" smtClean="0">
                          <a:latin typeface="Courier"/>
                          <a:ea typeface="Cambria"/>
                          <a:cs typeface="Times New Roman"/>
                        </a:rPr>
                        <a:t>-4T3</a:t>
                      </a: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498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61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GAGACATTCTAGTTGTAGCACAGCTAGCTACTGGTC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 smtClean="0">
                          <a:latin typeface="Courier"/>
                          <a:ea typeface="Calibri"/>
                          <a:cs typeface="Times New Roman"/>
                        </a:rPr>
                        <a:t>GST-PfRON2</a:t>
                      </a:r>
                      <a:r>
                        <a:rPr lang="en-US" sz="1000" b="0" cap="none" baseline="-25000" dirty="0" smtClean="0">
                          <a:latin typeface="Courier"/>
                          <a:ea typeface="Calibri"/>
                          <a:cs typeface="Times New Roman"/>
                        </a:rPr>
                        <a:t>F2038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b="0" cap="none" dirty="0" err="1" smtClean="0">
                          <a:latin typeface="Courier"/>
                          <a:ea typeface="Cambria"/>
                          <a:cs typeface="Times New Roman"/>
                        </a:rPr>
                        <a:t>pGEX</a:t>
                      </a:r>
                      <a:r>
                        <a:rPr lang="fr-FR" sz="1000" b="0" cap="none" dirty="0" smtClean="0">
                          <a:latin typeface="Courier"/>
                          <a:ea typeface="Cambria"/>
                          <a:cs typeface="Times New Roman"/>
                        </a:rPr>
                        <a:t>-4T3</a:t>
                      </a: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085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95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ACGGCGGATTCGCAGCTCCCCCTACTGAAC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i="1" cap="none" dirty="0">
                          <a:latin typeface="Courier"/>
                          <a:ea typeface="Calibri"/>
                          <a:cs typeface="Times New Roman"/>
                        </a:rPr>
                        <a:t>Pf</a:t>
                      </a: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AMA1</a:t>
                      </a:r>
                      <a:r>
                        <a:rPr lang="en-US" sz="1000" b="0" cap="none" baseline="-25000" dirty="0">
                          <a:latin typeface="Courier"/>
                          <a:ea typeface="Calibri"/>
                          <a:cs typeface="Times New Roman"/>
                        </a:rPr>
                        <a:t>F183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pcDNA3.1/</a:t>
                      </a:r>
                      <a:r>
                        <a:rPr lang="en-GB" sz="1000" kern="1200" dirty="0" err="1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myc</a:t>
                      </a: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-His(A) </a:t>
                      </a:r>
                      <a:endParaRPr lang="fr-FR" sz="1000" b="0" cap="none" dirty="0">
                        <a:latin typeface="Courier" pitchFamily="49" charset="0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085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96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GTTCAGTAGGGGGAGCTGCGAATCCGCCGT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PfAMA1</a:t>
                      </a:r>
                      <a:r>
                        <a:rPr lang="en-US" sz="1000" b="0" cap="none" baseline="-25000" dirty="0">
                          <a:latin typeface="Courier"/>
                          <a:ea typeface="Calibri"/>
                          <a:cs typeface="Times New Roman"/>
                        </a:rPr>
                        <a:t>F183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pcDNA3.1/</a:t>
                      </a:r>
                      <a:r>
                        <a:rPr lang="en-GB" sz="1000" kern="1200" dirty="0" err="1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myc</a:t>
                      </a: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-His(A) </a:t>
                      </a:r>
                      <a:endParaRPr lang="fr-FR" sz="1000" b="0" cap="none" dirty="0" smtClean="0">
                        <a:latin typeface="Courier" pitchFamily="49" charset="0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085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64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CAAGACATGCAGGAGCTATGATTCCAGATAATG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PfAMA1</a:t>
                      </a:r>
                      <a:r>
                        <a:rPr lang="en-US" sz="1000" b="0" cap="none" baseline="-25000" dirty="0">
                          <a:latin typeface="Courier"/>
                          <a:ea typeface="Calibri"/>
                          <a:cs typeface="Times New Roman"/>
                        </a:rPr>
                        <a:t>N223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pcDNA3.1/</a:t>
                      </a:r>
                      <a:r>
                        <a:rPr lang="en-GB" sz="1000" kern="1200" dirty="0" err="1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myc</a:t>
                      </a: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-His(A) </a:t>
                      </a:r>
                      <a:endParaRPr lang="fr-FR" sz="1000" b="0" cap="none" dirty="0" smtClean="0">
                        <a:latin typeface="Courier" pitchFamily="49" charset="0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085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65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CATTATCTGGAATCATAGCTCCTGCATGTCTTG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PfAMA1</a:t>
                      </a:r>
                      <a:r>
                        <a:rPr lang="en-US" sz="1000" b="0" cap="none" baseline="-25000" dirty="0">
                          <a:latin typeface="Courier"/>
                          <a:ea typeface="Calibri"/>
                          <a:cs typeface="Times New Roman"/>
                        </a:rPr>
                        <a:t>N223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pcDNA3.1/</a:t>
                      </a:r>
                      <a:r>
                        <a:rPr lang="en-GB" sz="1000" kern="1200" dirty="0" err="1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myc</a:t>
                      </a: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-His(A) </a:t>
                      </a:r>
                      <a:endParaRPr lang="fr-FR" sz="1000" b="0" cap="none" dirty="0" smtClean="0">
                        <a:latin typeface="Courier" pitchFamily="49" charset="0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085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97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CATGCAGGAAACATGGCCCCAGACAACGATAAG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PfAMA1</a:t>
                      </a:r>
                      <a:r>
                        <a:rPr lang="en-US" sz="1000" b="0" cap="none" baseline="-25000" dirty="0">
                          <a:latin typeface="Courier"/>
                          <a:ea typeface="Calibri"/>
                          <a:cs typeface="Times New Roman"/>
                        </a:rPr>
                        <a:t>I225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pcDNA3.1/</a:t>
                      </a:r>
                      <a:r>
                        <a:rPr lang="en-GB" sz="1000" kern="1200" dirty="0" err="1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myc</a:t>
                      </a: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-His(A) </a:t>
                      </a:r>
                      <a:endParaRPr lang="fr-FR" sz="1000" b="0" cap="none" dirty="0" smtClean="0">
                        <a:latin typeface="Courier" pitchFamily="49" charset="0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085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98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CTTATCGTTGTCTGGGGCCATGTTTCCTGCATG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PfAMA1</a:t>
                      </a:r>
                      <a:r>
                        <a:rPr lang="en-US" sz="1000" b="0" cap="none" baseline="-25000" dirty="0">
                          <a:latin typeface="Courier"/>
                          <a:ea typeface="Calibri"/>
                          <a:cs typeface="Times New Roman"/>
                        </a:rPr>
                        <a:t>I225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pcDNA3.1/</a:t>
                      </a:r>
                      <a:r>
                        <a:rPr lang="en-GB" sz="1000" kern="1200" dirty="0" err="1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myc</a:t>
                      </a: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-His(A) </a:t>
                      </a:r>
                      <a:endParaRPr lang="fr-FR" sz="1000" b="0" cap="none" dirty="0" smtClean="0">
                        <a:latin typeface="Courier" pitchFamily="49" charset="0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085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32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GATAAGAACTCCAACGCCAAGTATCCCGCCGTG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PfAMA1</a:t>
                      </a:r>
                      <a:r>
                        <a:rPr lang="en-US" sz="1000" b="0" cap="none" baseline="-25000" dirty="0">
                          <a:latin typeface="Courier"/>
                          <a:ea typeface="Calibri"/>
                          <a:cs typeface="Times New Roman"/>
                        </a:rPr>
                        <a:t>Y234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pcDNA3.1/</a:t>
                      </a:r>
                      <a:r>
                        <a:rPr lang="en-GB" sz="1000" kern="1200" dirty="0" err="1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myc</a:t>
                      </a: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-His(A) </a:t>
                      </a:r>
                      <a:endParaRPr lang="fr-FR" sz="1000" b="0" cap="none" dirty="0" smtClean="0">
                        <a:latin typeface="Courier" pitchFamily="49" charset="0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085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733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CACGGCGGGATACTTGGCGTTGGAGTTCTTATC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PfAMA1</a:t>
                      </a:r>
                      <a:r>
                        <a:rPr lang="en-US" sz="1000" b="0" cap="none" baseline="-25000" dirty="0">
                          <a:latin typeface="Courier"/>
                          <a:ea typeface="Calibri"/>
                          <a:cs typeface="Times New Roman"/>
                        </a:rPr>
                        <a:t>Y234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pcDNA3.1/</a:t>
                      </a:r>
                      <a:r>
                        <a:rPr lang="en-GB" sz="1000" kern="1200" dirty="0" err="1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myc</a:t>
                      </a: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-His(A) </a:t>
                      </a:r>
                      <a:endParaRPr lang="fr-FR" sz="1000" b="0" cap="none" dirty="0" smtClean="0">
                        <a:latin typeface="Courier" pitchFamily="49" charset="0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085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ML535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AAATGTCACATCCTGGCTATTGCCGCTCAGGAA 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PfAMA1</a:t>
                      </a:r>
                      <a:r>
                        <a:rPr lang="en-US" sz="1000" b="0" cap="none" baseline="-25000" dirty="0">
                          <a:latin typeface="Courier"/>
                          <a:ea typeface="Calibri"/>
                          <a:cs typeface="Times New Roman"/>
                        </a:rPr>
                        <a:t>Y251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pcDNA3.1/</a:t>
                      </a:r>
                      <a:r>
                        <a:rPr lang="en-GB" sz="1000" kern="1200" dirty="0" err="1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myc</a:t>
                      </a: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-His(A) </a:t>
                      </a:r>
                      <a:endParaRPr lang="fr-FR" sz="1000" b="0" cap="none" dirty="0" smtClean="0">
                        <a:latin typeface="Courier" pitchFamily="49" charset="0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0852"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ML536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>
                          <a:latin typeface="Courier"/>
                          <a:ea typeface="Calibri"/>
                          <a:cs typeface="Times New Roman"/>
                        </a:rPr>
                        <a:t>TTCCTGAGCGGCAATAGCCAGGATGTGACATTT</a:t>
                      </a:r>
                      <a:endParaRPr lang="fr-FR" sz="1000" b="1" cap="none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1000"/>
                        </a:spcAft>
                      </a:pPr>
                      <a:r>
                        <a:rPr lang="en-US" sz="1000" b="0" cap="none" dirty="0">
                          <a:latin typeface="Courier"/>
                          <a:ea typeface="Calibri"/>
                          <a:cs typeface="Times New Roman"/>
                        </a:rPr>
                        <a:t>PfAMA1</a:t>
                      </a:r>
                      <a:r>
                        <a:rPr lang="en-US" sz="1000" b="0" cap="none" baseline="-25000" dirty="0">
                          <a:latin typeface="Courier"/>
                          <a:ea typeface="Calibri"/>
                          <a:cs typeface="Times New Roman"/>
                        </a:rPr>
                        <a:t>Y251A</a:t>
                      </a:r>
                      <a:endParaRPr lang="fr-FR" sz="1000" b="1" cap="none" dirty="0">
                        <a:latin typeface="Courier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pcDNA3.1/</a:t>
                      </a:r>
                      <a:r>
                        <a:rPr lang="en-GB" sz="1000" kern="1200" dirty="0" err="1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myc</a:t>
                      </a:r>
                      <a:r>
                        <a:rPr lang="en-GB" sz="1000" kern="1200" dirty="0" smtClean="0">
                          <a:solidFill>
                            <a:schemeClr val="tx1"/>
                          </a:solidFill>
                          <a:latin typeface="Courier" pitchFamily="49" charset="0"/>
                          <a:ea typeface="+mn-ea"/>
                          <a:cs typeface="+mn-cs"/>
                        </a:rPr>
                        <a:t>-His(A) </a:t>
                      </a:r>
                      <a:endParaRPr lang="fr-FR" sz="1000" b="0" cap="none" dirty="0" smtClean="0">
                        <a:latin typeface="Courier" pitchFamily="49" charset="0"/>
                        <a:ea typeface="Cambria"/>
                        <a:cs typeface="Times New Roman"/>
                      </a:endParaRPr>
                    </a:p>
                  </a:txBody>
                  <a:tcPr marL="3930" marR="3930" marT="678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0" y="0"/>
            <a:ext cx="6858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4" name="ZoneTexte 3"/>
          <p:cNvSpPr txBox="1"/>
          <p:nvPr/>
        </p:nvSpPr>
        <p:spPr>
          <a:xfrm>
            <a:off x="381000" y="228600"/>
            <a:ext cx="5638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Table S3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521</TotalTime>
  <Words>669</Words>
  <Application>Microsoft Office PowerPoint</Application>
  <PresentationFormat>Format US (216 x 279 mm)</PresentationFormat>
  <Paragraphs>414</Paragraphs>
  <Slides>3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4" baseType="lpstr">
      <vt:lpstr>Office Theme</vt:lpstr>
      <vt:lpstr>Diapositive 1</vt:lpstr>
      <vt:lpstr>Diapositive 2</vt:lpstr>
      <vt:lpstr>Diapositive 3</vt:lpstr>
    </vt:vector>
  </TitlesOfParts>
  <Company>Grizli777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chelle</dc:creator>
  <cp:lastModifiedBy>Maryse</cp:lastModifiedBy>
  <cp:revision>432</cp:revision>
  <cp:lastPrinted>2011-06-14T08:21:48Z</cp:lastPrinted>
  <dcterms:created xsi:type="dcterms:W3CDTF">2011-06-14T08:21:34Z</dcterms:created>
  <dcterms:modified xsi:type="dcterms:W3CDTF">2012-05-10T12:23:48Z</dcterms:modified>
</cp:coreProperties>
</file>